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58F33-96A5-48A4-BEB4-23FB277D94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9FBFD-660A-4262-8F04-1FDAC66997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9F509-939F-4E05-9711-257585B00D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CA3F1-8968-4DE1-8E1A-B6BD114F84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D5445-7AF6-4A61-BD6F-AA5251E76E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E97C9-1AF6-42BD-95DF-0E6E250935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8F4FB-F2AB-42EA-86F7-17B35DA061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6D746-5758-4852-A3A9-0840E98FB9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BDC5B-1FCA-4D05-B126-8C4D1DABBF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11A1B-2652-4012-809A-DB44368FF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FF5C3-590A-4846-9797-9B2B79F895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FFC2F-C82C-41C8-884D-85BB884D29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C5D9A3-B9D0-4AA6-B022-6E3A13FEB7C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8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4.png"/><Relationship Id="rId3" Type="http://schemas.openxmlformats.org/officeDocument/2006/relationships/image" Target="../media/image1.png"/><Relationship Id="rId4" Type="http://schemas.openxmlformats.org/officeDocument/2006/relationships/image" Target="../media/image4.png"/><Relationship Id="rId5" Type="http://schemas.openxmlformats.org/officeDocument/2006/relationships/image" Target="../media/image1.png"/><Relationship Id="rId6" Type="http://schemas.openxmlformats.org/officeDocument/2006/relationships/image" Target="../media/image4.png"/><Relationship Id="rId7" Type="http://schemas.openxmlformats.org/officeDocument/2006/relationships/image" Target="../media/image1.png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3922560" y="1837440"/>
            <a:ext cx="201384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NF</a:t>
            </a:r>
            <a:r>
              <a:rPr b="1" lang="pl-PL" sz="14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B-SEAP/</a:t>
            </a:r>
            <a:r>
              <a:rPr b="1" lang="el-GR" sz="14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-gal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751360" y="1706400"/>
            <a:ext cx="603360" cy="120672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751360" y="1706400"/>
            <a:ext cx="601920" cy="1206720"/>
          </a:xfrm>
          <a:custGeom>
            <a:avLst/>
            <a:gdLst/>
            <a:ahLst/>
            <a:rect l="l" t="t" r="r" b="b"/>
            <a:pathLst>
              <a:path w="399" h="800">
                <a:moveTo>
                  <a:pt x="0" y="800"/>
                </a:moveTo>
                <a:lnTo>
                  <a:pt x="0" y="0"/>
                </a:lnTo>
                <a:lnTo>
                  <a:pt x="399" y="0"/>
                </a:lnTo>
                <a:lnTo>
                  <a:pt x="399" y="80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656400" y="1766880"/>
            <a:ext cx="603360" cy="114624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656400" y="1766880"/>
            <a:ext cx="601560" cy="1146240"/>
          </a:xfrm>
          <a:custGeom>
            <a:avLst/>
            <a:gdLst/>
            <a:ahLst/>
            <a:rect l="l" t="t" r="r" b="b"/>
            <a:pathLst>
              <a:path w="399" h="760">
                <a:moveTo>
                  <a:pt x="0" y="760"/>
                </a:moveTo>
                <a:lnTo>
                  <a:pt x="0" y="0"/>
                </a:lnTo>
                <a:lnTo>
                  <a:pt x="399" y="0"/>
                </a:lnTo>
                <a:lnTo>
                  <a:pt x="399" y="76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807240" y="1660680"/>
            <a:ext cx="301680" cy="360"/>
          </a:xfrm>
          <a:custGeom>
            <a:avLst/>
            <a:gdLst/>
            <a:ahLst/>
            <a:rect l="l" t="t" r="r" b="b"/>
            <a:pathLst>
              <a:path w="200" h="0">
                <a:moveTo>
                  <a:pt x="0" y="0"/>
                </a:moveTo>
                <a:lnTo>
                  <a:pt x="2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958080" y="1660680"/>
            <a:ext cx="0" cy="1062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561440" y="1905120"/>
            <a:ext cx="604800" cy="100800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561440" y="1905120"/>
            <a:ext cx="603000" cy="1008000"/>
          </a:xfrm>
          <a:custGeom>
            <a:avLst/>
            <a:gdLst/>
            <a:ahLst/>
            <a:rect l="l" t="t" r="r" b="b"/>
            <a:pathLst>
              <a:path w="399" h="668">
                <a:moveTo>
                  <a:pt x="0" y="668"/>
                </a:moveTo>
                <a:lnTo>
                  <a:pt x="0" y="0"/>
                </a:lnTo>
                <a:lnTo>
                  <a:pt x="399" y="0"/>
                </a:lnTo>
                <a:lnTo>
                  <a:pt x="399" y="668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711920" y="1851120"/>
            <a:ext cx="303480" cy="360"/>
          </a:xfrm>
          <a:custGeom>
            <a:avLst/>
            <a:gdLst/>
            <a:ahLst/>
            <a:rect l="l" t="t" r="r" b="b"/>
            <a:pathLst>
              <a:path w="200" h="0">
                <a:moveTo>
                  <a:pt x="0" y="0"/>
                </a:moveTo>
                <a:lnTo>
                  <a:pt x="2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862760" y="1851120"/>
            <a:ext cx="0" cy="540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600880" y="2913120"/>
            <a:ext cx="2716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5600880" y="1103040"/>
            <a:ext cx="0" cy="18097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5546880" y="291312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382360" y="283212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5546880" y="230976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302440" y="222876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H="1">
            <a:off x="5546880" y="170640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224320" y="162576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224320" y="102240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792760" y="3059280"/>
            <a:ext cx="509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7595640" y="305928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O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25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732360" y="305928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AA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10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246320" y="1673280"/>
            <a:ext cx="609480" cy="121932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246320" y="1673280"/>
            <a:ext cx="608040" cy="1219320"/>
          </a:xfrm>
          <a:custGeom>
            <a:avLst/>
            <a:gdLst/>
            <a:ahLst/>
            <a:rect l="l" t="t" r="r" b="b"/>
            <a:pathLst>
              <a:path w="399" h="800">
                <a:moveTo>
                  <a:pt x="0" y="800"/>
                </a:moveTo>
                <a:lnTo>
                  <a:pt x="0" y="0"/>
                </a:lnTo>
                <a:lnTo>
                  <a:pt x="399" y="0"/>
                </a:lnTo>
                <a:lnTo>
                  <a:pt x="399" y="80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160720" y="1730520"/>
            <a:ext cx="609480" cy="116208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160720" y="1730520"/>
            <a:ext cx="608040" cy="1162080"/>
          </a:xfrm>
          <a:custGeom>
            <a:avLst/>
            <a:gdLst/>
            <a:ahLst/>
            <a:rect l="l" t="t" r="r" b="b"/>
            <a:pathLst>
              <a:path w="399" h="763">
                <a:moveTo>
                  <a:pt x="0" y="763"/>
                </a:moveTo>
                <a:lnTo>
                  <a:pt x="0" y="0"/>
                </a:lnTo>
                <a:lnTo>
                  <a:pt x="399" y="0"/>
                </a:lnTo>
                <a:lnTo>
                  <a:pt x="399" y="763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313000" y="1305000"/>
            <a:ext cx="304920" cy="360"/>
          </a:xfrm>
          <a:custGeom>
            <a:avLst/>
            <a:gdLst/>
            <a:ahLst/>
            <a:rect l="l" t="t" r="r" b="b"/>
            <a:pathLst>
              <a:path w="200" h="0">
                <a:moveTo>
                  <a:pt x="0" y="0"/>
                </a:moveTo>
                <a:lnTo>
                  <a:pt x="2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465280" y="1305000"/>
            <a:ext cx="0" cy="4255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075120" y="2192400"/>
            <a:ext cx="609480" cy="70020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075120" y="2192400"/>
            <a:ext cx="608040" cy="700200"/>
          </a:xfrm>
          <a:custGeom>
            <a:avLst/>
            <a:gdLst/>
            <a:ahLst/>
            <a:rect l="l" t="t" r="r" b="b"/>
            <a:pathLst>
              <a:path w="399" h="460">
                <a:moveTo>
                  <a:pt x="0" y="460"/>
                </a:moveTo>
                <a:lnTo>
                  <a:pt x="0" y="0"/>
                </a:lnTo>
                <a:lnTo>
                  <a:pt x="399" y="0"/>
                </a:lnTo>
                <a:lnTo>
                  <a:pt x="399" y="46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227400" y="2084400"/>
            <a:ext cx="304920" cy="360"/>
          </a:xfrm>
          <a:custGeom>
            <a:avLst/>
            <a:gdLst/>
            <a:ahLst/>
            <a:rect l="l" t="t" r="r" b="b"/>
            <a:pathLst>
              <a:path w="200" h="0">
                <a:moveTo>
                  <a:pt x="0" y="0"/>
                </a:moveTo>
                <a:lnTo>
                  <a:pt x="2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379680" y="2084400"/>
            <a:ext cx="0" cy="1080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093680" y="2892600"/>
            <a:ext cx="27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1093680" y="1063800"/>
            <a:ext cx="0" cy="18288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1041120" y="289260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810360" y="280980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H="1">
            <a:off x="1041120" y="228276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58880" y="22003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H="1">
            <a:off x="1041120" y="167328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82560" y="159084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1041120" y="106380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82560" y="98100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276200" y="3059280"/>
            <a:ext cx="509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131640" y="305928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O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25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215800" y="305928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AA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10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rot="16200000">
            <a:off x="-77040" y="1868040"/>
            <a:ext cx="10828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SP-1 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349440" y="16178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33280" y="184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389840" y="18900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7956360" y="3984480"/>
            <a:ext cx="697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Fig.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"/>
          <p:cNvSpPr/>
          <p:nvPr/>
        </p:nvSpPr>
        <p:spPr>
          <a:xfrm>
            <a:off x="4138560" y="3084480"/>
            <a:ext cx="31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A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994200" y="3513240"/>
            <a:ext cx="579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hypoxi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318320" y="300816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-          +          +           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391760" y="3441600"/>
            <a:ext cx="244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-          -          +           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445080" y="9856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344600" y="2624040"/>
            <a:ext cx="457200" cy="14616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344600" y="2624040"/>
            <a:ext cx="455760" cy="146160"/>
          </a:xfrm>
          <a:custGeom>
            <a:avLst/>
            <a:gdLst/>
            <a:ahLst/>
            <a:rect l="l" t="t" r="r" b="b"/>
            <a:pathLst>
              <a:path w="299" h="96">
                <a:moveTo>
                  <a:pt x="0" y="96"/>
                </a:moveTo>
                <a:lnTo>
                  <a:pt x="0" y="0"/>
                </a:lnTo>
                <a:lnTo>
                  <a:pt x="299" y="0"/>
                </a:lnTo>
                <a:lnTo>
                  <a:pt x="299" y="96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030400" y="2597040"/>
            <a:ext cx="457200" cy="17316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030400" y="2597040"/>
            <a:ext cx="455760" cy="173160"/>
          </a:xfrm>
          <a:custGeom>
            <a:avLst/>
            <a:gdLst/>
            <a:ahLst/>
            <a:rect l="l" t="t" r="r" b="b"/>
            <a:pathLst>
              <a:path w="299" h="114">
                <a:moveTo>
                  <a:pt x="0" y="114"/>
                </a:moveTo>
                <a:lnTo>
                  <a:pt x="0" y="0"/>
                </a:lnTo>
                <a:lnTo>
                  <a:pt x="299" y="0"/>
                </a:lnTo>
                <a:lnTo>
                  <a:pt x="299" y="114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144880" y="2581200"/>
            <a:ext cx="2286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259000" y="2581200"/>
            <a:ext cx="0" cy="15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716200" y="1657440"/>
            <a:ext cx="457200" cy="111276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716200" y="1657440"/>
            <a:ext cx="455760" cy="1112760"/>
          </a:xfrm>
          <a:custGeom>
            <a:avLst/>
            <a:gdLst/>
            <a:ahLst/>
            <a:rect l="l" t="t" r="r" b="b"/>
            <a:pathLst>
              <a:path w="299" h="730">
                <a:moveTo>
                  <a:pt x="0" y="730"/>
                </a:moveTo>
                <a:lnTo>
                  <a:pt x="0" y="0"/>
                </a:lnTo>
                <a:lnTo>
                  <a:pt x="299" y="0"/>
                </a:lnTo>
                <a:lnTo>
                  <a:pt x="299" y="73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830680" y="1347840"/>
            <a:ext cx="2286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944800" y="1347840"/>
            <a:ext cx="0" cy="3096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402000" y="1459080"/>
            <a:ext cx="457200" cy="131112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402000" y="1459080"/>
            <a:ext cx="455760" cy="1311120"/>
          </a:xfrm>
          <a:custGeom>
            <a:avLst/>
            <a:gdLst/>
            <a:ahLst/>
            <a:rect l="l" t="t" r="r" b="b"/>
            <a:pathLst>
              <a:path w="299" h="861">
                <a:moveTo>
                  <a:pt x="0" y="861"/>
                </a:moveTo>
                <a:lnTo>
                  <a:pt x="0" y="0"/>
                </a:lnTo>
                <a:lnTo>
                  <a:pt x="299" y="0"/>
                </a:lnTo>
                <a:lnTo>
                  <a:pt x="299" y="861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516480" y="1225440"/>
            <a:ext cx="2286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630600" y="1225440"/>
            <a:ext cx="0" cy="233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230480" y="2770200"/>
            <a:ext cx="27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1230480" y="941400"/>
            <a:ext cx="0" cy="18288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flipH="1">
            <a:off x="1176480" y="277020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013760" y="268776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H="1">
            <a:off x="1176480" y="240660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857160" y="232416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flipH="1">
            <a:off x="1176480" y="203976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857160" y="195912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H="1">
            <a:off x="1176480" y="167472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857160" y="159228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7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flipH="1">
            <a:off x="1176480" y="130968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778680" y="1227240"/>
            <a:ext cx="36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flipH="1">
            <a:off x="1176480" y="94284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778680" y="860400"/>
            <a:ext cx="36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686560" y="1892160"/>
            <a:ext cx="457200" cy="91440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686560" y="1892160"/>
            <a:ext cx="455400" cy="914400"/>
          </a:xfrm>
          <a:custGeom>
            <a:avLst/>
            <a:gdLst/>
            <a:ahLst/>
            <a:rect l="l" t="t" r="r" b="b"/>
            <a:pathLst>
              <a:path w="299" h="600">
                <a:moveTo>
                  <a:pt x="0" y="600"/>
                </a:moveTo>
                <a:lnTo>
                  <a:pt x="0" y="0"/>
                </a:lnTo>
                <a:lnTo>
                  <a:pt x="299" y="0"/>
                </a:lnTo>
                <a:lnTo>
                  <a:pt x="299" y="60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6372360" y="1484280"/>
            <a:ext cx="457200" cy="132228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372360" y="1484280"/>
            <a:ext cx="455400" cy="1322280"/>
          </a:xfrm>
          <a:custGeom>
            <a:avLst/>
            <a:gdLst/>
            <a:ahLst/>
            <a:rect l="l" t="t" r="r" b="b"/>
            <a:pathLst>
              <a:path w="299" h="868">
                <a:moveTo>
                  <a:pt x="0" y="868"/>
                </a:moveTo>
                <a:lnTo>
                  <a:pt x="0" y="0"/>
                </a:lnTo>
                <a:lnTo>
                  <a:pt x="299" y="0"/>
                </a:lnTo>
                <a:lnTo>
                  <a:pt x="299" y="868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486480" y="1265400"/>
            <a:ext cx="2286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600960" y="1265400"/>
            <a:ext cx="0" cy="218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7058160" y="1415880"/>
            <a:ext cx="457200" cy="1390680"/>
          </a:xfrm>
          <a:prstGeom prst="rect">
            <a:avLst/>
          </a:prstGeom>
          <a:blipFill rotWithShape="0">
            <a:blip r:embed="rId7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7058160" y="1415880"/>
            <a:ext cx="455400" cy="1390680"/>
          </a:xfrm>
          <a:custGeom>
            <a:avLst/>
            <a:gdLst/>
            <a:ahLst/>
            <a:rect l="l" t="t" r="r" b="b"/>
            <a:pathLst>
              <a:path w="299" h="913">
                <a:moveTo>
                  <a:pt x="0" y="913"/>
                </a:moveTo>
                <a:lnTo>
                  <a:pt x="0" y="0"/>
                </a:lnTo>
                <a:lnTo>
                  <a:pt x="299" y="0"/>
                </a:lnTo>
                <a:lnTo>
                  <a:pt x="299" y="913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7172280" y="1197000"/>
            <a:ext cx="2286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7286760" y="1197000"/>
            <a:ext cx="0" cy="218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7743960" y="1284120"/>
            <a:ext cx="457200" cy="1522440"/>
          </a:xfrm>
          <a:prstGeom prst="rect">
            <a:avLst/>
          </a:prstGeom>
          <a:blipFill rotWithShape="0">
            <a:blip r:embed="rId8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7743960" y="1284120"/>
            <a:ext cx="455400" cy="1522440"/>
          </a:xfrm>
          <a:custGeom>
            <a:avLst/>
            <a:gdLst/>
            <a:ahLst/>
            <a:rect l="l" t="t" r="r" b="b"/>
            <a:pathLst>
              <a:path w="299" h="999">
                <a:moveTo>
                  <a:pt x="0" y="999"/>
                </a:moveTo>
                <a:lnTo>
                  <a:pt x="0" y="0"/>
                </a:lnTo>
                <a:lnTo>
                  <a:pt x="299" y="0"/>
                </a:lnTo>
                <a:lnTo>
                  <a:pt x="299" y="999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7858080" y="1190520"/>
            <a:ext cx="2286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7972560" y="1190520"/>
            <a:ext cx="0" cy="936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572080" y="2806560"/>
            <a:ext cx="27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V="1">
            <a:off x="5572080" y="977760"/>
            <a:ext cx="0" cy="18288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H="1">
            <a:off x="5518080" y="280656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5355360" y="272412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H="1">
            <a:off x="5518080" y="189216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5198760" y="180972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H="1">
            <a:off x="5518080" y="977760"/>
            <a:ext cx="54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5198760" y="89532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8459640" y="3011400"/>
            <a:ext cx="31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A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8315280" y="3440160"/>
            <a:ext cx="579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hypoxi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5639760" y="293544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-          +          +           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5711040" y="336852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-           -          +           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rot="16200000">
            <a:off x="-396000" y="1567800"/>
            <a:ext cx="172116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HRE-luc/</a:t>
            </a:r>
            <a:r>
              <a:rPr b="1" lang="el-GR" sz="14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-gal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rot="16200000">
            <a:off x="4366080" y="1554120"/>
            <a:ext cx="112716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VEGF prote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7873920" y="9144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3492360" y="9144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33280" y="184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389840" y="18900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8172360" y="4102200"/>
            <a:ext cx="697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Fig.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"/>
          <p:cNvSpPr/>
          <p:nvPr/>
        </p:nvSpPr>
        <p:spPr>
          <a:xfrm rot="16200000">
            <a:off x="-107280" y="1411920"/>
            <a:ext cx="172116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HRE-luc/</a:t>
            </a:r>
            <a:r>
              <a:rPr b="1" lang="el-GR" sz="14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-gal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773360" y="1417680"/>
            <a:ext cx="871560" cy="116352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773360" y="1417680"/>
            <a:ext cx="869760" cy="1163520"/>
          </a:xfrm>
          <a:custGeom>
            <a:avLst/>
            <a:gdLst/>
            <a:ahLst/>
            <a:rect l="l" t="t" r="r" b="b"/>
            <a:pathLst>
              <a:path w="599" h="800">
                <a:moveTo>
                  <a:pt x="0" y="800"/>
                </a:moveTo>
                <a:lnTo>
                  <a:pt x="0" y="0"/>
                </a:lnTo>
                <a:lnTo>
                  <a:pt x="599" y="0"/>
                </a:lnTo>
                <a:lnTo>
                  <a:pt x="599" y="80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081240" y="2052720"/>
            <a:ext cx="873360" cy="52848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081240" y="2052720"/>
            <a:ext cx="871560" cy="528480"/>
          </a:xfrm>
          <a:custGeom>
            <a:avLst/>
            <a:gdLst/>
            <a:ahLst/>
            <a:rect l="l" t="t" r="r" b="b"/>
            <a:pathLst>
              <a:path w="599" h="363">
                <a:moveTo>
                  <a:pt x="0" y="363"/>
                </a:moveTo>
                <a:lnTo>
                  <a:pt x="0" y="0"/>
                </a:lnTo>
                <a:lnTo>
                  <a:pt x="599" y="0"/>
                </a:lnTo>
                <a:lnTo>
                  <a:pt x="599" y="363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3300480" y="1976400"/>
            <a:ext cx="43488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517920" y="1976400"/>
            <a:ext cx="0" cy="763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554120" y="2581200"/>
            <a:ext cx="26179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flipV="1">
            <a:off x="1554120" y="835200"/>
            <a:ext cx="0" cy="17460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H="1">
            <a:off x="1503000" y="258120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340640" y="250200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H="1">
            <a:off x="1503000" y="199872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263960" y="192096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H="1">
            <a:off x="1503000" y="141768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185480" y="133812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H="1">
            <a:off x="1503000" y="83520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185480" y="75708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1904760" y="2708280"/>
            <a:ext cx="509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276360" y="264312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O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25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771560" y="4657680"/>
            <a:ext cx="873360" cy="11635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771560" y="4657680"/>
            <a:ext cx="871560" cy="1163520"/>
          </a:xfrm>
          <a:custGeom>
            <a:avLst/>
            <a:gdLst/>
            <a:ahLst/>
            <a:rect l="l" t="t" r="r" b="b"/>
            <a:pathLst>
              <a:path w="599" h="800">
                <a:moveTo>
                  <a:pt x="0" y="800"/>
                </a:moveTo>
                <a:lnTo>
                  <a:pt x="0" y="0"/>
                </a:lnTo>
                <a:lnTo>
                  <a:pt x="599" y="0"/>
                </a:lnTo>
                <a:lnTo>
                  <a:pt x="599" y="80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3081240" y="4280040"/>
            <a:ext cx="871560" cy="154116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081240" y="4280040"/>
            <a:ext cx="870120" cy="1541160"/>
          </a:xfrm>
          <a:custGeom>
            <a:avLst/>
            <a:gdLst/>
            <a:ahLst/>
            <a:rect l="l" t="t" r="r" b="b"/>
            <a:pathLst>
              <a:path w="599" h="1059">
                <a:moveTo>
                  <a:pt x="0" y="1059"/>
                </a:moveTo>
                <a:lnTo>
                  <a:pt x="0" y="0"/>
                </a:lnTo>
                <a:lnTo>
                  <a:pt x="599" y="0"/>
                </a:lnTo>
                <a:lnTo>
                  <a:pt x="599" y="1059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298680" y="4102200"/>
            <a:ext cx="43668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3516480" y="4102200"/>
            <a:ext cx="0" cy="177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554120" y="5821200"/>
            <a:ext cx="26161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V="1">
            <a:off x="1554120" y="4075200"/>
            <a:ext cx="0" cy="17460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flipH="1">
            <a:off x="1503000" y="582120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1340640" y="574200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flipH="1">
            <a:off x="1503000" y="523872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1263960" y="516096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 flipH="1">
            <a:off x="1503000" y="465768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185480" y="457848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H="1">
            <a:off x="1503000" y="407520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185480" y="399744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rot="16200000">
            <a:off x="-182160" y="4579200"/>
            <a:ext cx="201384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NF</a:t>
            </a:r>
            <a:r>
              <a:rPr b="1" lang="pl-PL" sz="14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B-SEAP/</a:t>
            </a:r>
            <a:r>
              <a:rPr b="1" lang="el-GR" sz="14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-gal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1923840" y="5942160"/>
            <a:ext cx="509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276360" y="587700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O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25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5799240" y="1393920"/>
            <a:ext cx="888840" cy="118728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5799240" y="1393920"/>
            <a:ext cx="887400" cy="1187280"/>
          </a:xfrm>
          <a:custGeom>
            <a:avLst/>
            <a:gdLst/>
            <a:ahLst/>
            <a:rect l="l" t="t" r="r" b="b"/>
            <a:pathLst>
              <a:path w="599" h="800">
                <a:moveTo>
                  <a:pt x="0" y="800"/>
                </a:moveTo>
                <a:lnTo>
                  <a:pt x="0" y="0"/>
                </a:lnTo>
                <a:lnTo>
                  <a:pt x="599" y="0"/>
                </a:lnTo>
                <a:lnTo>
                  <a:pt x="599" y="80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7132680" y="1670040"/>
            <a:ext cx="888840" cy="91116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7132680" y="1670040"/>
            <a:ext cx="887400" cy="911160"/>
          </a:xfrm>
          <a:custGeom>
            <a:avLst/>
            <a:gdLst/>
            <a:ahLst/>
            <a:rect l="l" t="t" r="r" b="b"/>
            <a:pathLst>
              <a:path w="599" h="614">
                <a:moveTo>
                  <a:pt x="0" y="614"/>
                </a:moveTo>
                <a:lnTo>
                  <a:pt x="0" y="0"/>
                </a:lnTo>
                <a:lnTo>
                  <a:pt x="599" y="0"/>
                </a:lnTo>
                <a:lnTo>
                  <a:pt x="599" y="614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7354800" y="1573200"/>
            <a:ext cx="44460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7577280" y="1573200"/>
            <a:ext cx="0" cy="96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5576760" y="2581200"/>
            <a:ext cx="26672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V="1">
            <a:off x="5576760" y="799920"/>
            <a:ext cx="0" cy="17809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 flipH="1">
            <a:off x="5524200" y="258120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5361840" y="250020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 flipH="1">
            <a:off x="5524200" y="198756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5284800" y="190656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flipH="1">
            <a:off x="5524200" y="139392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5206680" y="131436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H="1">
            <a:off x="5524200" y="800280"/>
            <a:ext cx="52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5206680" y="72072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rot="16200000">
            <a:off x="4005720" y="1348560"/>
            <a:ext cx="194652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AP-1-SEAP/</a:t>
            </a:r>
            <a:r>
              <a:rPr b="1" lang="el-GR" sz="14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-gal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5986440" y="2708280"/>
            <a:ext cx="509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7357680" y="264312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O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25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5803920" y="4676760"/>
            <a:ext cx="873000" cy="1162080"/>
          </a:xfrm>
          <a:prstGeom prst="rect">
            <a:avLst/>
          </a:prstGeom>
          <a:blipFill rotWithShape="0">
            <a:blip r:embed="rId7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5803920" y="4676760"/>
            <a:ext cx="871560" cy="1162080"/>
          </a:xfrm>
          <a:custGeom>
            <a:avLst/>
            <a:gdLst/>
            <a:ahLst/>
            <a:rect l="l" t="t" r="r" b="b"/>
            <a:pathLst>
              <a:path w="599" h="800">
                <a:moveTo>
                  <a:pt x="0" y="800"/>
                </a:moveTo>
                <a:lnTo>
                  <a:pt x="0" y="0"/>
                </a:lnTo>
                <a:lnTo>
                  <a:pt x="599" y="0"/>
                </a:lnTo>
                <a:lnTo>
                  <a:pt x="599" y="80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7113600" y="4795920"/>
            <a:ext cx="871560" cy="1042920"/>
          </a:xfrm>
          <a:prstGeom prst="rect">
            <a:avLst/>
          </a:prstGeom>
          <a:blipFill rotWithShape="0">
            <a:blip r:embed="rId8"/>
            <a:srcRect/>
            <a:tile tx="0" ty="0" sx="100000" sy="100000" algn="ctr"/>
          </a:blip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7113600" y="4795920"/>
            <a:ext cx="869760" cy="1042920"/>
          </a:xfrm>
          <a:custGeom>
            <a:avLst/>
            <a:gdLst/>
            <a:ahLst/>
            <a:rect l="l" t="t" r="r" b="b"/>
            <a:pathLst>
              <a:path w="599" h="718">
                <a:moveTo>
                  <a:pt x="0" y="718"/>
                </a:moveTo>
                <a:lnTo>
                  <a:pt x="0" y="0"/>
                </a:lnTo>
                <a:lnTo>
                  <a:pt x="599" y="0"/>
                </a:lnTo>
                <a:lnTo>
                  <a:pt x="599" y="718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7331040" y="4635360"/>
            <a:ext cx="43668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7548480" y="4635360"/>
            <a:ext cx="0" cy="1620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5586480" y="5838840"/>
            <a:ext cx="26161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 flipV="1">
            <a:off x="5586480" y="4095720"/>
            <a:ext cx="0" cy="17431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 flipH="1">
            <a:off x="5535360" y="583884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5373000" y="576108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flipH="1">
            <a:off x="5535360" y="525780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5295960" y="518004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 flipH="1">
            <a:off x="5535360" y="467676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5217840" y="459756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flipH="1">
            <a:off x="5535360" y="4095720"/>
            <a:ext cx="50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5217840" y="401652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rot="16200000">
            <a:off x="4083480" y="4506120"/>
            <a:ext cx="169200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SP-1-luc/</a:t>
            </a:r>
            <a:r>
              <a:rPr b="1" lang="el-GR" sz="14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-gal ac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pl-PL" sz="1400" spc="-1" strike="noStrike">
                <a:solidFill>
                  <a:srgbClr val="000000"/>
                </a:solidFill>
                <a:latin typeface="Times New Roman"/>
              </a:rPr>
              <a:t>[% of control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6008760" y="5942160"/>
            <a:ext cx="509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7380000" y="5877000"/>
            <a:ext cx="48528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O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25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pl-PL" sz="14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3373560" y="1650960"/>
            <a:ext cx="29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7396200" y="12492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346200" y="37800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8172360" y="6407280"/>
            <a:ext cx="697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Fig.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1T18:55:08Z</dcterms:created>
  <dc:creator>Ania</dc:creator>
  <dc:description/>
  <dc:language>en-US</dc:language>
  <cp:lastModifiedBy>Aga</cp:lastModifiedBy>
  <dcterms:modified xsi:type="dcterms:W3CDTF">2011-04-20T10:49:38Z</dcterms:modified>
  <cp:revision>12</cp:revision>
  <dc:subject/>
  <dc:title>Slajd 1</dc:title>
</cp:coreProperties>
</file>